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909E2-D3C0-4B1A-A99E-1C15C3EBBE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EB139-EEE4-4AE8-8F50-C77818CA30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E5FD9-112D-4967-A8D7-6838CF4037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1EBC3-60FF-405E-AB31-246A03DA61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284F3-E5E7-49AF-AAE7-EA82AD94B7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3095A-4C95-49D0-A3C0-2398D71E5D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78221-920B-4ED9-8E2D-34BB954A2D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B5D38-C2A3-4595-83E1-83EE91732A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8C9E1-A13A-425B-B6C0-AF2AF99C21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10495-A8F3-4997-8B4C-25D50F63DB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D9986-FC2C-4186-ADDB-9DF234C179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94848-B357-4B5D-9D8E-75A11C96B2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B33682-C640-46B0-8EEE-DE19797394D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18"/>
          <p:cNvGraphicFramePr/>
          <p:nvPr/>
        </p:nvGraphicFramePr>
        <p:xfrm>
          <a:off x="766800" y="766800"/>
          <a:ext cx="7329600" cy="54417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1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6800" y="766800"/>
                    <a:ext cx="7329600" cy="5441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Rectangle 2"/>
          <p:cNvSpPr/>
          <p:nvPr/>
        </p:nvSpPr>
        <p:spPr>
          <a:xfrm>
            <a:off x="541800" y="203040"/>
            <a:ext cx="806616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fferentially expressed cell cycle genes in early HCV relative to normal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9"/>
          <p:cNvSpPr/>
          <p:nvPr/>
        </p:nvSpPr>
        <p:spPr>
          <a:xfrm flipH="1">
            <a:off x="1015920" y="6172200"/>
            <a:ext cx="18288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0"/>
          <p:cNvSpPr/>
          <p:nvPr/>
        </p:nvSpPr>
        <p:spPr>
          <a:xfrm>
            <a:off x="1078200" y="624528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own regu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1"/>
          <p:cNvSpPr/>
          <p:nvPr/>
        </p:nvSpPr>
        <p:spPr>
          <a:xfrm>
            <a:off x="5867280" y="6172200"/>
            <a:ext cx="198144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2"/>
          <p:cNvSpPr/>
          <p:nvPr/>
        </p:nvSpPr>
        <p:spPr>
          <a:xfrm>
            <a:off x="6478200" y="6245280"/>
            <a:ext cx="111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p regu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15"/>
          <p:cNvGraphicFramePr/>
          <p:nvPr/>
        </p:nvGraphicFramePr>
        <p:xfrm>
          <a:off x="0" y="1150920"/>
          <a:ext cx="8686800" cy="52056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9" name="Object 1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150920"/>
                    <a:ext cx="8686800" cy="520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2"/>
          <p:cNvSpPr/>
          <p:nvPr/>
        </p:nvSpPr>
        <p:spPr>
          <a:xfrm>
            <a:off x="123840" y="152280"/>
            <a:ext cx="9144000" cy="69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2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fferentially expressed cell cycle genes in advanced HCV relative to early HC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6"/>
          <p:cNvSpPr/>
          <p:nvPr/>
        </p:nvSpPr>
        <p:spPr>
          <a:xfrm flipH="1">
            <a:off x="762120" y="6324480"/>
            <a:ext cx="18288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7"/>
          <p:cNvSpPr/>
          <p:nvPr/>
        </p:nvSpPr>
        <p:spPr>
          <a:xfrm>
            <a:off x="824040" y="639756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own regu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8"/>
          <p:cNvSpPr/>
          <p:nvPr/>
        </p:nvSpPr>
        <p:spPr>
          <a:xfrm>
            <a:off x="6400800" y="6327720"/>
            <a:ext cx="182880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9"/>
          <p:cNvSpPr/>
          <p:nvPr/>
        </p:nvSpPr>
        <p:spPr>
          <a:xfrm>
            <a:off x="6859080" y="6400800"/>
            <a:ext cx="111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p regu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1T06:49:22Z</dcterms:created>
  <dc:creator>Saira Sarfraz</dc:creator>
  <dc:description/>
  <dc:language>en-US</dc:language>
  <cp:lastModifiedBy>Khalid Bashir</cp:lastModifiedBy>
  <dcterms:modified xsi:type="dcterms:W3CDTF">2008-11-19T11:40:21Z</dcterms:modified>
  <cp:revision>14</cp:revision>
  <dc:subject/>
  <dc:title>Slide 1</dc:title>
</cp:coreProperties>
</file>